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  <p:sldId id="258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7" d="100"/>
          <a:sy n="77" d="100"/>
        </p:scale>
        <p:origin x="883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E81C72E-609A-7434-5C9D-B4852BF0EA5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A6845EBE-2488-900B-C30E-E103DB2EB81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F59C177-BECA-6F02-CC39-CACE901317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2F2BA-2262-466D-8B61-AB84C6886503}" type="datetimeFigureOut">
              <a:rPr lang="zh-CN" altLang="en-US" smtClean="0"/>
              <a:t>2023/11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2998808-9E31-4184-341C-80DC908842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29C6D45-4085-2190-2FCC-8151D3C997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D4B4E-72E6-4917-95DE-97566CFBBA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19433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D7FB833-2D38-D761-420A-5CDF4DBB80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F377315-255C-3BAB-5B7F-2A9121752C5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A9E5B55-E42E-E4EC-C8B1-E3C5ADF17A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2F2BA-2262-466D-8B61-AB84C6886503}" type="datetimeFigureOut">
              <a:rPr lang="zh-CN" altLang="en-US" smtClean="0"/>
              <a:t>2023/11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21099D3-B105-826C-1348-13047D7F99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99DA036-579A-8ACB-07C9-32A7C4EDBB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D4B4E-72E6-4917-95DE-97566CFBBA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334247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854AFF0E-7C9A-FA41-3818-E1B6967F9D2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C71626E-29AF-2D2D-2D8C-DBC095F2450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9F59A83-3C33-5CA2-8798-021DB4809F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2F2BA-2262-466D-8B61-AB84C6886503}" type="datetimeFigureOut">
              <a:rPr lang="zh-CN" altLang="en-US" smtClean="0"/>
              <a:t>2023/11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0977061-C899-3EB2-1EFA-760B872E0F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D139110-1333-5792-4E37-79C10E39C0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D4B4E-72E6-4917-95DE-97566CFBBA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20760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4540B71-6FA8-2B9F-A89C-2E3B9A412A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AFD1820-D784-D264-D75B-95653476653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D481C98-966E-1D9B-309E-09152AEA1F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2F2BA-2262-466D-8B61-AB84C6886503}" type="datetimeFigureOut">
              <a:rPr lang="zh-CN" altLang="en-US" smtClean="0"/>
              <a:t>2023/11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A4BD20E-2442-6DC0-4E25-5BDB81D2C5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8B9D27F-EF0C-E5FA-C72A-00D170DEA8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D4B4E-72E6-4917-95DE-97566CFBBA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874193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7FAD90A-88BB-74F1-3544-49232A77DA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66587E7-1CC9-A985-4C9A-0877B4DA5C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6473FF2-8721-0F92-077E-80996F4655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2F2BA-2262-466D-8B61-AB84C6886503}" type="datetimeFigureOut">
              <a:rPr lang="zh-CN" altLang="en-US" smtClean="0"/>
              <a:t>2023/11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0586B98-315C-0D4C-EB90-87AEBE188E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E3B3DDE-C36C-1592-3134-083D2CF9D9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D4B4E-72E6-4917-95DE-97566CFBBA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658368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3790949-1CDD-CC86-4C29-1C273C0A1C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CEFAC0D-BB37-E4B3-F600-0C050DEFC01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28FD623-902A-8F09-616D-A5089197969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D3C3BE6-B7D4-0056-3319-298BF94F06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2F2BA-2262-466D-8B61-AB84C6886503}" type="datetimeFigureOut">
              <a:rPr lang="zh-CN" altLang="en-US" smtClean="0"/>
              <a:t>2023/11/2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C32A22C-0338-A41E-EFD8-9FCBC877D1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8526438-1E82-D12D-70C0-F552560D59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D4B4E-72E6-4917-95DE-97566CFBBA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32767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EBEA0A7-2985-877B-3FD4-4663677D5C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B4C57C2-B27A-1BD6-FA2B-F6CFA21ADE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D6E2172-2C9A-CF3A-E940-DE7DDCF9B30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250C9C52-497D-88D2-908B-FA9BBD94A10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F017677B-7393-FF28-479A-02AC44087ED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B2320930-79DD-D87B-AAD5-CB27522C32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2F2BA-2262-466D-8B61-AB84C6886503}" type="datetimeFigureOut">
              <a:rPr lang="zh-CN" altLang="en-US" smtClean="0"/>
              <a:t>2023/11/21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2E8C01B-562C-5328-90E3-871277B767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E3315D91-4AF7-3EC0-93AD-E80827F493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D4B4E-72E6-4917-95DE-97566CFBBA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54924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C89332A-D452-5164-F662-AA88D4C311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B8534D2C-0B04-9A3E-FBFD-DB59C4F618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2F2BA-2262-466D-8B61-AB84C6886503}" type="datetimeFigureOut">
              <a:rPr lang="zh-CN" altLang="en-US" smtClean="0"/>
              <a:t>2023/11/21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0278138F-0184-3B74-2B1F-0C2E18FF5D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8C759001-817E-1860-7C17-188F31775B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D4B4E-72E6-4917-95DE-97566CFBBA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32681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83A78B0A-04B5-E79B-B402-7CCD3E7394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2F2BA-2262-466D-8B61-AB84C6886503}" type="datetimeFigureOut">
              <a:rPr lang="zh-CN" altLang="en-US" smtClean="0"/>
              <a:t>2023/11/21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BE23B155-CAA4-3C7D-047B-5AFF99819F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5FC54B26-4138-A4E0-D52D-273D4E7A83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D4B4E-72E6-4917-95DE-97566CFBBA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03210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F3E9E0F-CB67-FD84-9601-E0FF574D8D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F4E7D64-BA15-9827-A368-912ABE3D2DC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A8FE33B-CC12-A178-D719-DA54E7FA541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77BB877-291B-F9C1-4891-E479F8A0CF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2F2BA-2262-466D-8B61-AB84C6886503}" type="datetimeFigureOut">
              <a:rPr lang="zh-CN" altLang="en-US" smtClean="0"/>
              <a:t>2023/11/2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7F19C35-B4A2-B5EA-0291-4675C82CDF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CBB724A-2753-EF29-71F7-418000D4BA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D4B4E-72E6-4917-95DE-97566CFBBA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94818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61CD2D0-F9AB-9257-824E-3A42CDC501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52ECFFB2-52D4-BB93-4592-5531D417F9B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47E7579-1DF7-8E5B-2B1B-4C4F739FADE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29BB707-72DD-012F-F0FB-E8F0233CE4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2F2BA-2262-466D-8B61-AB84C6886503}" type="datetimeFigureOut">
              <a:rPr lang="zh-CN" altLang="en-US" smtClean="0"/>
              <a:t>2023/11/2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233C45A-8B54-DCFF-46E2-F68738D7ED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9173DD3-8F28-66F7-FFE9-CFCFC13620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D4B4E-72E6-4917-95DE-97566CFBBA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07903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1F776A0A-6083-B68D-7A70-61DC86E098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2A8A8B5-2524-F743-6840-D369F29E0C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5CB330C-FD14-9403-5438-8FDEE94C2A2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02F2BA-2262-466D-8B61-AB84C6886503}" type="datetimeFigureOut">
              <a:rPr lang="zh-CN" altLang="en-US" smtClean="0"/>
              <a:t>2023/11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9248081-6C3B-94F4-4D8D-FB4B9A65D25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11C8778-F0CF-653D-0C7A-1218876A065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FD4B4E-72E6-4917-95DE-97566CFBBA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27690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jpeg"/><Relationship Id="rId13" Type="http://schemas.openxmlformats.org/officeDocument/2006/relationships/image" Target="../media/image16.jpeg"/><Relationship Id="rId18" Type="http://schemas.openxmlformats.org/officeDocument/2006/relationships/image" Target="../media/image21.jpeg"/><Relationship Id="rId3" Type="http://schemas.openxmlformats.org/officeDocument/2006/relationships/image" Target="../media/image6.jpeg"/><Relationship Id="rId7" Type="http://schemas.openxmlformats.org/officeDocument/2006/relationships/image" Target="../media/image10.jpeg"/><Relationship Id="rId12" Type="http://schemas.openxmlformats.org/officeDocument/2006/relationships/image" Target="../media/image15.jpeg"/><Relationship Id="rId17" Type="http://schemas.openxmlformats.org/officeDocument/2006/relationships/image" Target="../media/image20.jpeg"/><Relationship Id="rId2" Type="http://schemas.openxmlformats.org/officeDocument/2006/relationships/image" Target="../media/image5.jpeg"/><Relationship Id="rId16" Type="http://schemas.openxmlformats.org/officeDocument/2006/relationships/image" Target="../media/image19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jpeg"/><Relationship Id="rId11" Type="http://schemas.openxmlformats.org/officeDocument/2006/relationships/image" Target="../media/image14.jpeg"/><Relationship Id="rId5" Type="http://schemas.openxmlformats.org/officeDocument/2006/relationships/image" Target="../media/image8.jpeg"/><Relationship Id="rId15" Type="http://schemas.openxmlformats.org/officeDocument/2006/relationships/image" Target="../media/image18.jpeg"/><Relationship Id="rId10" Type="http://schemas.openxmlformats.org/officeDocument/2006/relationships/image" Target="../media/image13.jpeg"/><Relationship Id="rId19" Type="http://schemas.openxmlformats.org/officeDocument/2006/relationships/image" Target="../media/image22.jpeg"/><Relationship Id="rId4" Type="http://schemas.openxmlformats.org/officeDocument/2006/relationships/image" Target="../media/image7.jpeg"/><Relationship Id="rId9" Type="http://schemas.openxmlformats.org/officeDocument/2006/relationships/image" Target="../media/image12.jpeg"/><Relationship Id="rId14" Type="http://schemas.openxmlformats.org/officeDocument/2006/relationships/image" Target="../media/image17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jpeg"/><Relationship Id="rId3" Type="http://schemas.openxmlformats.org/officeDocument/2006/relationships/image" Target="../media/image24.jpeg"/><Relationship Id="rId7" Type="http://schemas.openxmlformats.org/officeDocument/2006/relationships/image" Target="../media/image28.jpeg"/><Relationship Id="rId2" Type="http://schemas.openxmlformats.org/officeDocument/2006/relationships/image" Target="../media/image23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7.jpeg"/><Relationship Id="rId5" Type="http://schemas.openxmlformats.org/officeDocument/2006/relationships/image" Target="../media/image26.jpeg"/><Relationship Id="rId10" Type="http://schemas.openxmlformats.org/officeDocument/2006/relationships/image" Target="../media/image31.jpeg"/><Relationship Id="rId4" Type="http://schemas.openxmlformats.org/officeDocument/2006/relationships/image" Target="../media/image25.tiff"/><Relationship Id="rId9" Type="http://schemas.openxmlformats.org/officeDocument/2006/relationships/image" Target="../media/image30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401F9C48-CE8A-FDF7-C553-F7E47D8990D4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714" t="71917" r="54556" b="13759"/>
          <a:stretch/>
        </p:blipFill>
        <p:spPr>
          <a:xfrm>
            <a:off x="7146235" y="2216427"/>
            <a:ext cx="1212574" cy="824947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61D5202F-1F25-EF48-8B54-9BDF928A264E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553" t="39300" r="59713" b="46376"/>
          <a:stretch/>
        </p:blipFill>
        <p:spPr>
          <a:xfrm>
            <a:off x="3856383" y="2259951"/>
            <a:ext cx="1003851" cy="91560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08290206-9F87-4FF5-2C3F-96DA7B4CA329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745" t="31189" r="51848" b="56040"/>
          <a:stretch/>
        </p:blipFill>
        <p:spPr>
          <a:xfrm>
            <a:off x="3703984" y="3220276"/>
            <a:ext cx="1341782" cy="735496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1DB4AC4A-AF11-794C-FA2B-8360869C2049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745" t="62253" r="51848" b="23423"/>
          <a:stretch/>
        </p:blipFill>
        <p:spPr>
          <a:xfrm>
            <a:off x="7146235" y="3175551"/>
            <a:ext cx="1341782" cy="824947"/>
          </a:xfrm>
          <a:prstGeom prst="rect">
            <a:avLst/>
          </a:prstGeom>
        </p:spPr>
      </p:pic>
      <p:sp>
        <p:nvSpPr>
          <p:cNvPr id="14" name="文本框 13">
            <a:extLst>
              <a:ext uri="{FF2B5EF4-FFF2-40B4-BE49-F238E27FC236}">
                <a16:creationId xmlns:a16="http://schemas.microsoft.com/office/drawing/2014/main" id="{7A20F37A-E6DC-8F7F-390D-7EBE13CF29B5}"/>
              </a:ext>
            </a:extLst>
          </p:cNvPr>
          <p:cNvSpPr txBox="1"/>
          <p:nvPr/>
        </p:nvSpPr>
        <p:spPr>
          <a:xfrm>
            <a:off x="2613994" y="2563502"/>
            <a:ext cx="16068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TBC1D8</a:t>
            </a:r>
            <a:endParaRPr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CF857ED0-A8BF-0AA0-6343-7B1D33C5452B}"/>
              </a:ext>
            </a:extLst>
          </p:cNvPr>
          <p:cNvSpPr txBox="1"/>
          <p:nvPr/>
        </p:nvSpPr>
        <p:spPr>
          <a:xfrm>
            <a:off x="5875683" y="2454173"/>
            <a:ext cx="16068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TBC1D14</a:t>
            </a:r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D87FA184-2AB2-E304-901C-DE436A4C8C2A}"/>
              </a:ext>
            </a:extLst>
          </p:cNvPr>
          <p:cNvSpPr txBox="1"/>
          <p:nvPr/>
        </p:nvSpPr>
        <p:spPr>
          <a:xfrm>
            <a:off x="2604055" y="3433969"/>
            <a:ext cx="16068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A1F77701-2207-443D-F774-A0263B76FB6A}"/>
              </a:ext>
            </a:extLst>
          </p:cNvPr>
          <p:cNvSpPr txBox="1"/>
          <p:nvPr/>
        </p:nvSpPr>
        <p:spPr>
          <a:xfrm>
            <a:off x="6044650" y="3403358"/>
            <a:ext cx="16068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EB5A958C-46A7-1734-0A10-E6F49C82DF52}"/>
              </a:ext>
            </a:extLst>
          </p:cNvPr>
          <p:cNvSpPr txBox="1"/>
          <p:nvPr/>
        </p:nvSpPr>
        <p:spPr>
          <a:xfrm>
            <a:off x="228603" y="178110"/>
            <a:ext cx="16068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.8A</a:t>
            </a:r>
            <a:endParaRPr lang="zh-CN" altLang="en-US" dirty="0"/>
          </a:p>
        </p:txBody>
      </p:sp>
      <p:cxnSp>
        <p:nvCxnSpPr>
          <p:cNvPr id="3" name="直接箭头连接符 2">
            <a:extLst>
              <a:ext uri="{FF2B5EF4-FFF2-40B4-BE49-F238E27FC236}">
                <a16:creationId xmlns:a16="http://schemas.microsoft.com/office/drawing/2014/main" id="{B939EFAF-7B7C-CE3F-E3B3-D839127321DD}"/>
              </a:ext>
            </a:extLst>
          </p:cNvPr>
          <p:cNvCxnSpPr/>
          <p:nvPr/>
        </p:nvCxnSpPr>
        <p:spPr>
          <a:xfrm flipH="1">
            <a:off x="4740966" y="2863261"/>
            <a:ext cx="427383" cy="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" name="直接箭头连接符 3">
            <a:extLst>
              <a:ext uri="{FF2B5EF4-FFF2-40B4-BE49-F238E27FC236}">
                <a16:creationId xmlns:a16="http://schemas.microsoft.com/office/drawing/2014/main" id="{802B2C3A-8E54-F3A6-A3BF-14629DCE67AE}"/>
              </a:ext>
            </a:extLst>
          </p:cNvPr>
          <p:cNvCxnSpPr/>
          <p:nvPr/>
        </p:nvCxnSpPr>
        <p:spPr>
          <a:xfrm flipH="1">
            <a:off x="4737654" y="2734052"/>
            <a:ext cx="427383" cy="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" name="直接箭头连接符 5">
            <a:extLst>
              <a:ext uri="{FF2B5EF4-FFF2-40B4-BE49-F238E27FC236}">
                <a16:creationId xmlns:a16="http://schemas.microsoft.com/office/drawing/2014/main" id="{089DC2FF-5C0E-DFB6-8888-C3744BE9050B}"/>
              </a:ext>
            </a:extLst>
          </p:cNvPr>
          <p:cNvCxnSpPr/>
          <p:nvPr/>
        </p:nvCxnSpPr>
        <p:spPr>
          <a:xfrm flipH="1">
            <a:off x="4740966" y="2654539"/>
            <a:ext cx="427383" cy="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" name="直接箭头连接符 7">
            <a:extLst>
              <a:ext uri="{FF2B5EF4-FFF2-40B4-BE49-F238E27FC236}">
                <a16:creationId xmlns:a16="http://schemas.microsoft.com/office/drawing/2014/main" id="{9935C5C0-132A-96E4-77ED-83640559647A}"/>
              </a:ext>
            </a:extLst>
          </p:cNvPr>
          <p:cNvCxnSpPr/>
          <p:nvPr/>
        </p:nvCxnSpPr>
        <p:spPr>
          <a:xfrm flipH="1">
            <a:off x="4618383" y="3509304"/>
            <a:ext cx="427383" cy="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" name="直接箭头连接符 10">
            <a:extLst>
              <a:ext uri="{FF2B5EF4-FFF2-40B4-BE49-F238E27FC236}">
                <a16:creationId xmlns:a16="http://schemas.microsoft.com/office/drawing/2014/main" id="{647E31CB-9520-E082-6D6F-BFD0677A4865}"/>
              </a:ext>
            </a:extLst>
          </p:cNvPr>
          <p:cNvCxnSpPr/>
          <p:nvPr/>
        </p:nvCxnSpPr>
        <p:spPr>
          <a:xfrm flipH="1">
            <a:off x="4626663" y="3688209"/>
            <a:ext cx="427383" cy="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直接箭头连接符 11">
            <a:extLst>
              <a:ext uri="{FF2B5EF4-FFF2-40B4-BE49-F238E27FC236}">
                <a16:creationId xmlns:a16="http://schemas.microsoft.com/office/drawing/2014/main" id="{89C50BBB-7CAE-965F-E9E6-DC0EB0FB9904}"/>
              </a:ext>
            </a:extLst>
          </p:cNvPr>
          <p:cNvCxnSpPr/>
          <p:nvPr/>
        </p:nvCxnSpPr>
        <p:spPr>
          <a:xfrm flipH="1">
            <a:off x="8050695" y="2613197"/>
            <a:ext cx="427383" cy="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直接箭头连接符 12">
            <a:extLst>
              <a:ext uri="{FF2B5EF4-FFF2-40B4-BE49-F238E27FC236}">
                <a16:creationId xmlns:a16="http://schemas.microsoft.com/office/drawing/2014/main" id="{8A52EFB3-7E52-12D4-3C1D-6F7801867A60}"/>
              </a:ext>
            </a:extLst>
          </p:cNvPr>
          <p:cNvCxnSpPr/>
          <p:nvPr/>
        </p:nvCxnSpPr>
        <p:spPr>
          <a:xfrm flipH="1">
            <a:off x="8050695" y="2793686"/>
            <a:ext cx="427383" cy="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直接箭头连接符 18">
            <a:extLst>
              <a:ext uri="{FF2B5EF4-FFF2-40B4-BE49-F238E27FC236}">
                <a16:creationId xmlns:a16="http://schemas.microsoft.com/office/drawing/2014/main" id="{4D8B900E-466F-7F2A-87E0-DF8B5C84ADC3}"/>
              </a:ext>
            </a:extLst>
          </p:cNvPr>
          <p:cNvCxnSpPr/>
          <p:nvPr/>
        </p:nvCxnSpPr>
        <p:spPr>
          <a:xfrm flipH="1">
            <a:off x="8060634" y="3500155"/>
            <a:ext cx="427383" cy="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直接箭头连接符 19">
            <a:extLst>
              <a:ext uri="{FF2B5EF4-FFF2-40B4-BE49-F238E27FC236}">
                <a16:creationId xmlns:a16="http://schemas.microsoft.com/office/drawing/2014/main" id="{F95C67B5-EBC1-4587-0174-C05B5340E17B}"/>
              </a:ext>
            </a:extLst>
          </p:cNvPr>
          <p:cNvCxnSpPr/>
          <p:nvPr/>
        </p:nvCxnSpPr>
        <p:spPr>
          <a:xfrm flipH="1">
            <a:off x="8060634" y="3688209"/>
            <a:ext cx="427383" cy="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文本框 20">
            <a:extLst>
              <a:ext uri="{FF2B5EF4-FFF2-40B4-BE49-F238E27FC236}">
                <a16:creationId xmlns:a16="http://schemas.microsoft.com/office/drawing/2014/main" id="{B43FDD01-D089-1A73-E8C5-8D74CCD514CE}"/>
              </a:ext>
            </a:extLst>
          </p:cNvPr>
          <p:cNvSpPr txBox="1"/>
          <p:nvPr/>
        </p:nvSpPr>
        <p:spPr>
          <a:xfrm>
            <a:off x="5141021" y="2463070"/>
            <a:ext cx="6452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180kD</a:t>
            </a:r>
            <a:endParaRPr lang="zh-CN" altLang="en-US" sz="1200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1BC0AF7E-FB31-FFD1-56C0-FEE2A55D2A4C}"/>
              </a:ext>
            </a:extLst>
          </p:cNvPr>
          <p:cNvSpPr txBox="1"/>
          <p:nvPr/>
        </p:nvSpPr>
        <p:spPr>
          <a:xfrm>
            <a:off x="5141021" y="2793686"/>
            <a:ext cx="6452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100kD</a:t>
            </a:r>
            <a:endParaRPr lang="zh-CN" altLang="en-US" sz="1200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DE60787B-3F85-1586-37D3-3775693BC05E}"/>
              </a:ext>
            </a:extLst>
          </p:cNvPr>
          <p:cNvSpPr txBox="1"/>
          <p:nvPr/>
        </p:nvSpPr>
        <p:spPr>
          <a:xfrm>
            <a:off x="5141021" y="2611508"/>
            <a:ext cx="6452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130kD</a:t>
            </a:r>
            <a:endParaRPr lang="zh-CN" altLang="en-US" sz="1200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1CC9A604-A7F1-23DE-51B6-23946D5993A7}"/>
              </a:ext>
            </a:extLst>
          </p:cNvPr>
          <p:cNvSpPr txBox="1"/>
          <p:nvPr/>
        </p:nvSpPr>
        <p:spPr>
          <a:xfrm>
            <a:off x="5073924" y="3576110"/>
            <a:ext cx="6452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40kD</a:t>
            </a:r>
            <a:endParaRPr lang="zh-CN" altLang="en-US" sz="1200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D47BB9E4-F398-9057-9912-AFF578719E6D}"/>
              </a:ext>
            </a:extLst>
          </p:cNvPr>
          <p:cNvSpPr txBox="1"/>
          <p:nvPr/>
        </p:nvSpPr>
        <p:spPr>
          <a:xfrm>
            <a:off x="5073924" y="3393932"/>
            <a:ext cx="6452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55kD</a:t>
            </a:r>
            <a:endParaRPr lang="zh-CN" altLang="en-US" sz="1200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EE2F7CE7-6F96-29E8-5570-C39CCB1B5DF4}"/>
              </a:ext>
            </a:extLst>
          </p:cNvPr>
          <p:cNvSpPr txBox="1"/>
          <p:nvPr/>
        </p:nvSpPr>
        <p:spPr>
          <a:xfrm>
            <a:off x="8482216" y="2656229"/>
            <a:ext cx="6452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55kD</a:t>
            </a:r>
            <a:endParaRPr lang="zh-CN" altLang="en-US" sz="1200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BC50FC95-56BF-021C-7121-31B62B58666C}"/>
              </a:ext>
            </a:extLst>
          </p:cNvPr>
          <p:cNvSpPr txBox="1"/>
          <p:nvPr/>
        </p:nvSpPr>
        <p:spPr>
          <a:xfrm>
            <a:off x="8482216" y="2474051"/>
            <a:ext cx="6452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70kD</a:t>
            </a:r>
            <a:endParaRPr lang="zh-CN" altLang="en-US" sz="1200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69345A64-E78A-D214-287B-C13D2A5895A7}"/>
              </a:ext>
            </a:extLst>
          </p:cNvPr>
          <p:cNvSpPr txBox="1"/>
          <p:nvPr/>
        </p:nvSpPr>
        <p:spPr>
          <a:xfrm>
            <a:off x="8488017" y="3527093"/>
            <a:ext cx="6452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40kD</a:t>
            </a:r>
            <a:endParaRPr lang="zh-CN" altLang="en-US" sz="1200" dirty="0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C2E02306-4AAD-C0E4-0AE0-B5C494C6BF26}"/>
              </a:ext>
            </a:extLst>
          </p:cNvPr>
          <p:cNvSpPr txBox="1"/>
          <p:nvPr/>
        </p:nvSpPr>
        <p:spPr>
          <a:xfrm>
            <a:off x="8488017" y="3344915"/>
            <a:ext cx="6452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55kD</a:t>
            </a:r>
            <a:endParaRPr lang="zh-CN" altLang="en-US" sz="1200" dirty="0"/>
          </a:p>
        </p:txBody>
      </p:sp>
    </p:spTree>
    <p:extLst>
      <p:ext uri="{BB962C8B-B14F-4D97-AF65-F5344CB8AC3E}">
        <p14:creationId xmlns:p14="http://schemas.microsoft.com/office/powerpoint/2010/main" val="31613339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B4B3E322-E314-C360-1FE3-ADA1B05842D6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4139" y="824949"/>
            <a:ext cx="1179443" cy="884583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79A8CE89-0CF6-9417-D1A4-38DA75EA8C65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4137" y="2678600"/>
            <a:ext cx="1179443" cy="884582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36B982D6-50B6-81F2-8F66-4EA2B9BFBD15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4138" y="1749290"/>
            <a:ext cx="1179443" cy="884582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083FAF18-2366-9EC9-AA12-5459084C1418}"/>
              </a:ext>
            </a:extLst>
          </p:cNvPr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4137" y="5605675"/>
            <a:ext cx="1179443" cy="884582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A8981E5D-3F81-8270-2C52-1ADA19FE2D2F}"/>
              </a:ext>
            </a:extLst>
          </p:cNvPr>
          <p:cNvPicPr>
            <a:picLocks noChangeAspect="1"/>
          </p:cNvPicPr>
          <p:nvPr/>
        </p:nvPicPr>
        <p:blipFill>
          <a:blip r:embed="rId6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4137" y="4663939"/>
            <a:ext cx="1179443" cy="884583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4092608E-BE95-6972-DE9F-ACD97C2F0D6E}"/>
              </a:ext>
            </a:extLst>
          </p:cNvPr>
          <p:cNvPicPr>
            <a:picLocks noChangeAspect="1"/>
          </p:cNvPicPr>
          <p:nvPr/>
        </p:nvPicPr>
        <p:blipFill>
          <a:blip r:embed="rId7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4137" y="3727183"/>
            <a:ext cx="1179443" cy="884583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41C830FE-6B26-290E-EC8D-A9D47D51A023}"/>
              </a:ext>
            </a:extLst>
          </p:cNvPr>
          <p:cNvPicPr>
            <a:picLocks noChangeAspect="1"/>
          </p:cNvPicPr>
          <p:nvPr/>
        </p:nvPicPr>
        <p:blipFill>
          <a:blip r:embed="rId8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84202" y="824949"/>
            <a:ext cx="1179443" cy="884582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39959599-0F0F-0619-9EE7-A4FDC2992826}"/>
              </a:ext>
            </a:extLst>
          </p:cNvPr>
          <p:cNvPicPr>
            <a:picLocks noChangeAspect="1"/>
          </p:cNvPicPr>
          <p:nvPr/>
        </p:nvPicPr>
        <p:blipFill>
          <a:blip r:embed="rId9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84202" y="1749290"/>
            <a:ext cx="1179443" cy="884582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F0291711-F935-5786-2ECB-8B3704DBFDCB}"/>
              </a:ext>
            </a:extLst>
          </p:cNvPr>
          <p:cNvPicPr>
            <a:picLocks noChangeAspect="1"/>
          </p:cNvPicPr>
          <p:nvPr/>
        </p:nvPicPr>
        <p:blipFill>
          <a:blip r:embed="rId10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84202" y="2673632"/>
            <a:ext cx="1179443" cy="884582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07D50F6D-B479-8841-40D3-48799C15FAA5}"/>
              </a:ext>
            </a:extLst>
          </p:cNvPr>
          <p:cNvPicPr>
            <a:picLocks noChangeAspect="1"/>
          </p:cNvPicPr>
          <p:nvPr/>
        </p:nvPicPr>
        <p:blipFill>
          <a:blip r:embed="rId11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84202" y="5615600"/>
            <a:ext cx="1179443" cy="884582"/>
          </a:xfrm>
          <a:prstGeom prst="rect">
            <a:avLst/>
          </a:prstGeom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id="{52AF04A9-FAB2-E08A-81E8-4864176D979B}"/>
              </a:ext>
            </a:extLst>
          </p:cNvPr>
          <p:cNvPicPr>
            <a:picLocks noChangeAspect="1"/>
          </p:cNvPicPr>
          <p:nvPr/>
        </p:nvPicPr>
        <p:blipFill>
          <a:blip r:embed="rId1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84202" y="3712279"/>
            <a:ext cx="1179443" cy="884582"/>
          </a:xfrm>
          <a:prstGeom prst="rect">
            <a:avLst/>
          </a:prstGeom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id="{73AACCA9-3BF4-6500-B660-99082467D890}"/>
              </a:ext>
            </a:extLst>
          </p:cNvPr>
          <p:cNvPicPr>
            <a:picLocks noChangeAspect="1"/>
          </p:cNvPicPr>
          <p:nvPr/>
        </p:nvPicPr>
        <p:blipFill>
          <a:blip r:embed="rId1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84202" y="4663939"/>
            <a:ext cx="1179443" cy="884582"/>
          </a:xfrm>
          <a:prstGeom prst="rect">
            <a:avLst/>
          </a:pr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83CB51C7-2F8A-253C-00A9-4B4856B2E2B8}"/>
              </a:ext>
            </a:extLst>
          </p:cNvPr>
          <p:cNvPicPr>
            <a:picLocks noChangeAspect="1"/>
          </p:cNvPicPr>
          <p:nvPr/>
        </p:nvPicPr>
        <p:blipFill>
          <a:blip r:embed="rId1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77335" y="2673632"/>
            <a:ext cx="1179443" cy="884582"/>
          </a:xfrm>
          <a:prstGeom prst="rect">
            <a:avLst/>
          </a:prstGeom>
        </p:spPr>
      </p:pic>
      <p:pic>
        <p:nvPicPr>
          <p:cNvPr id="33" name="图片 32">
            <a:extLst>
              <a:ext uri="{FF2B5EF4-FFF2-40B4-BE49-F238E27FC236}">
                <a16:creationId xmlns:a16="http://schemas.microsoft.com/office/drawing/2014/main" id="{09AF98C0-62CC-4AE8-5B5E-5BAF957851C9}"/>
              </a:ext>
            </a:extLst>
          </p:cNvPr>
          <p:cNvPicPr>
            <a:picLocks noChangeAspect="1"/>
          </p:cNvPicPr>
          <p:nvPr/>
        </p:nvPicPr>
        <p:blipFill>
          <a:blip r:embed="rId1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77335" y="1749290"/>
            <a:ext cx="1179443" cy="884583"/>
          </a:xfrm>
          <a:prstGeom prst="rect">
            <a:avLst/>
          </a:prstGeom>
        </p:spPr>
      </p:pic>
      <p:pic>
        <p:nvPicPr>
          <p:cNvPr id="35" name="图片 34">
            <a:extLst>
              <a:ext uri="{FF2B5EF4-FFF2-40B4-BE49-F238E27FC236}">
                <a16:creationId xmlns:a16="http://schemas.microsoft.com/office/drawing/2014/main" id="{CC27263A-D780-1EA3-AE15-E30F8E79D63F}"/>
              </a:ext>
            </a:extLst>
          </p:cNvPr>
          <p:cNvPicPr>
            <a:picLocks noChangeAspect="1"/>
          </p:cNvPicPr>
          <p:nvPr/>
        </p:nvPicPr>
        <p:blipFill>
          <a:blip r:embed="rId16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77335" y="824950"/>
            <a:ext cx="1179443" cy="884582"/>
          </a:xfrm>
          <a:prstGeom prst="rect">
            <a:avLst/>
          </a:prstGeom>
        </p:spPr>
      </p:pic>
      <p:pic>
        <p:nvPicPr>
          <p:cNvPr id="37" name="图片 36">
            <a:extLst>
              <a:ext uri="{FF2B5EF4-FFF2-40B4-BE49-F238E27FC236}">
                <a16:creationId xmlns:a16="http://schemas.microsoft.com/office/drawing/2014/main" id="{7314E5D1-CB05-BB63-9B16-2226549EE990}"/>
              </a:ext>
            </a:extLst>
          </p:cNvPr>
          <p:cNvPicPr>
            <a:picLocks noChangeAspect="1"/>
          </p:cNvPicPr>
          <p:nvPr/>
        </p:nvPicPr>
        <p:blipFill>
          <a:blip r:embed="rId17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77335" y="3712280"/>
            <a:ext cx="1179443" cy="884582"/>
          </a:xfrm>
          <a:prstGeom prst="rect">
            <a:avLst/>
          </a:prstGeom>
        </p:spPr>
      </p:pic>
      <p:pic>
        <p:nvPicPr>
          <p:cNvPr id="39" name="图片 38">
            <a:extLst>
              <a:ext uri="{FF2B5EF4-FFF2-40B4-BE49-F238E27FC236}">
                <a16:creationId xmlns:a16="http://schemas.microsoft.com/office/drawing/2014/main" id="{8D560CEC-9FBD-4C1B-45C6-E2032BFA40D1}"/>
              </a:ext>
            </a:extLst>
          </p:cNvPr>
          <p:cNvPicPr>
            <a:picLocks noChangeAspect="1"/>
          </p:cNvPicPr>
          <p:nvPr/>
        </p:nvPicPr>
        <p:blipFill>
          <a:blip r:embed="rId18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77335" y="4658973"/>
            <a:ext cx="1179443" cy="884582"/>
          </a:xfrm>
          <a:prstGeom prst="rect">
            <a:avLst/>
          </a:prstGeom>
        </p:spPr>
      </p:pic>
      <p:pic>
        <p:nvPicPr>
          <p:cNvPr id="41" name="图片 40">
            <a:extLst>
              <a:ext uri="{FF2B5EF4-FFF2-40B4-BE49-F238E27FC236}">
                <a16:creationId xmlns:a16="http://schemas.microsoft.com/office/drawing/2014/main" id="{C8D7D431-6E13-C8D9-3F57-06FC16B2775A}"/>
              </a:ext>
            </a:extLst>
          </p:cNvPr>
          <p:cNvPicPr>
            <a:picLocks noChangeAspect="1"/>
          </p:cNvPicPr>
          <p:nvPr/>
        </p:nvPicPr>
        <p:blipFill>
          <a:blip r:embed="rId19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77335" y="5615600"/>
            <a:ext cx="1179443" cy="884583"/>
          </a:xfrm>
          <a:prstGeom prst="rect">
            <a:avLst/>
          </a:prstGeom>
        </p:spPr>
      </p:pic>
      <p:sp>
        <p:nvSpPr>
          <p:cNvPr id="42" name="文本框 41">
            <a:extLst>
              <a:ext uri="{FF2B5EF4-FFF2-40B4-BE49-F238E27FC236}">
                <a16:creationId xmlns:a16="http://schemas.microsoft.com/office/drawing/2014/main" id="{7403BE71-F2FD-2748-1521-338530746E75}"/>
              </a:ext>
            </a:extLst>
          </p:cNvPr>
          <p:cNvSpPr txBox="1"/>
          <p:nvPr/>
        </p:nvSpPr>
        <p:spPr>
          <a:xfrm>
            <a:off x="228603" y="178110"/>
            <a:ext cx="16068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.8C</a:t>
            </a:r>
            <a:endParaRPr lang="zh-CN" altLang="en-US" dirty="0"/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DFEAFAB4-762B-455D-7726-9D05B76CD2D7}"/>
              </a:ext>
            </a:extLst>
          </p:cNvPr>
          <p:cNvSpPr txBox="1"/>
          <p:nvPr/>
        </p:nvSpPr>
        <p:spPr>
          <a:xfrm>
            <a:off x="3342857" y="493867"/>
            <a:ext cx="16068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sgNC</a:t>
            </a:r>
            <a:endParaRPr lang="zh-CN" altLang="en-US" dirty="0"/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7287A55B-5C30-6A8D-9578-553F6CA58399}"/>
              </a:ext>
            </a:extLst>
          </p:cNvPr>
          <p:cNvSpPr txBox="1"/>
          <p:nvPr/>
        </p:nvSpPr>
        <p:spPr>
          <a:xfrm>
            <a:off x="4527272" y="487809"/>
            <a:ext cx="16068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gTBC1D8</a:t>
            </a:r>
            <a:endParaRPr lang="zh-CN" altLang="en-US" dirty="0"/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3FD256B2-3683-E1DF-556D-7A9EC8AA48E9}"/>
              </a:ext>
            </a:extLst>
          </p:cNvPr>
          <p:cNvSpPr txBox="1"/>
          <p:nvPr/>
        </p:nvSpPr>
        <p:spPr>
          <a:xfrm>
            <a:off x="5902175" y="489615"/>
            <a:ext cx="16068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gTBC1D14</a:t>
            </a:r>
            <a:endParaRPr lang="zh-CN" altLang="en-US" dirty="0"/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B9A73744-9BD0-FAD2-181D-A10C45EB49CC}"/>
              </a:ext>
            </a:extLst>
          </p:cNvPr>
          <p:cNvSpPr txBox="1"/>
          <p:nvPr/>
        </p:nvSpPr>
        <p:spPr>
          <a:xfrm>
            <a:off x="1967117" y="2071521"/>
            <a:ext cx="16068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0 h</a:t>
            </a:r>
            <a:endParaRPr lang="zh-CN" altLang="en-US" dirty="0"/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CC66DEBD-B076-4D32-B6B0-9FF3A0D36DE5}"/>
              </a:ext>
            </a:extLst>
          </p:cNvPr>
          <p:cNvSpPr txBox="1"/>
          <p:nvPr/>
        </p:nvSpPr>
        <p:spPr>
          <a:xfrm>
            <a:off x="1988651" y="4778859"/>
            <a:ext cx="16068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48 h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8624555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D77D0C77-3BC0-D771-D906-CE409CC26DB4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16067" y="1888435"/>
            <a:ext cx="1504944" cy="1003296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BA606117-7E0E-ADF1-6E5F-5D09E8E56E1D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21456" y="1888435"/>
            <a:ext cx="1504944" cy="1003296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F113FC70-8006-744F-8317-8DBF586A1329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10678" y="1888435"/>
            <a:ext cx="1504944" cy="1003296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0BEA48CF-BEAF-3816-60A8-6DA3FB7FF042}"/>
              </a:ext>
            </a:extLst>
          </p:cNvPr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10679" y="3092730"/>
            <a:ext cx="1526898" cy="1017932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72DE3A50-0D06-E63B-76F7-2922076A1D69}"/>
              </a:ext>
            </a:extLst>
          </p:cNvPr>
          <p:cNvPicPr>
            <a:picLocks noChangeAspect="1"/>
          </p:cNvPicPr>
          <p:nvPr/>
        </p:nvPicPr>
        <p:blipFill>
          <a:blip r:embed="rId6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99503" y="3092729"/>
            <a:ext cx="1526897" cy="1017931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F4038B2D-573E-3BA9-2378-0C33B36E5069}"/>
              </a:ext>
            </a:extLst>
          </p:cNvPr>
          <p:cNvPicPr>
            <a:picLocks noChangeAspect="1"/>
          </p:cNvPicPr>
          <p:nvPr/>
        </p:nvPicPr>
        <p:blipFill>
          <a:blip r:embed="rId7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16068" y="3095485"/>
            <a:ext cx="1504944" cy="1003296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0EA93D14-CBF7-B77E-8246-FE45144D9015}"/>
              </a:ext>
            </a:extLst>
          </p:cNvPr>
          <p:cNvPicPr>
            <a:picLocks noChangeAspect="1"/>
          </p:cNvPicPr>
          <p:nvPr/>
        </p:nvPicPr>
        <p:blipFill>
          <a:blip r:embed="rId8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10678" y="4311659"/>
            <a:ext cx="1526897" cy="1017932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B6C0980A-1BC8-8D13-FA68-26676CA4C3A3}"/>
              </a:ext>
            </a:extLst>
          </p:cNvPr>
          <p:cNvPicPr>
            <a:picLocks noChangeAspect="1"/>
          </p:cNvPicPr>
          <p:nvPr/>
        </p:nvPicPr>
        <p:blipFill>
          <a:blip r:embed="rId9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99503" y="4311658"/>
            <a:ext cx="1526897" cy="1017931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FD91B737-2ECD-4E55-3611-D828D5C40B77}"/>
              </a:ext>
            </a:extLst>
          </p:cNvPr>
          <p:cNvPicPr>
            <a:picLocks noChangeAspect="1"/>
          </p:cNvPicPr>
          <p:nvPr/>
        </p:nvPicPr>
        <p:blipFill>
          <a:blip r:embed="rId10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16067" y="4338160"/>
            <a:ext cx="1504944" cy="1003296"/>
          </a:xfrm>
          <a:prstGeom prst="rect">
            <a:avLst/>
          </a:prstGeom>
        </p:spPr>
      </p:pic>
      <p:sp>
        <p:nvSpPr>
          <p:cNvPr id="22" name="文本框 21">
            <a:extLst>
              <a:ext uri="{FF2B5EF4-FFF2-40B4-BE49-F238E27FC236}">
                <a16:creationId xmlns:a16="http://schemas.microsoft.com/office/drawing/2014/main" id="{C75F343F-44AA-6777-C10A-8F9AE8425AE0}"/>
              </a:ext>
            </a:extLst>
          </p:cNvPr>
          <p:cNvSpPr txBox="1"/>
          <p:nvPr/>
        </p:nvSpPr>
        <p:spPr>
          <a:xfrm>
            <a:off x="1232454" y="2205417"/>
            <a:ext cx="16068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sgNC</a:t>
            </a:r>
            <a:endParaRPr lang="zh-CN" altLang="en-US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A34286DF-0C23-268C-3F58-F931DF54334B}"/>
              </a:ext>
            </a:extLst>
          </p:cNvPr>
          <p:cNvSpPr txBox="1"/>
          <p:nvPr/>
        </p:nvSpPr>
        <p:spPr>
          <a:xfrm>
            <a:off x="1232454" y="3390854"/>
            <a:ext cx="16068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gTBC1D8</a:t>
            </a:r>
            <a:endParaRPr lang="zh-CN" altLang="en-US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4F91C829-6A48-2636-F584-940D2F4134F0}"/>
              </a:ext>
            </a:extLst>
          </p:cNvPr>
          <p:cNvSpPr txBox="1"/>
          <p:nvPr/>
        </p:nvSpPr>
        <p:spPr>
          <a:xfrm>
            <a:off x="1232453" y="4635957"/>
            <a:ext cx="16068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gTBC1D14</a:t>
            </a:r>
            <a:endParaRPr lang="zh-CN" altLang="en-US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3BB26669-1B5B-A8B9-8D7D-7E092D224BA7}"/>
              </a:ext>
            </a:extLst>
          </p:cNvPr>
          <p:cNvSpPr txBox="1"/>
          <p:nvPr/>
        </p:nvSpPr>
        <p:spPr>
          <a:xfrm>
            <a:off x="228603" y="178110"/>
            <a:ext cx="16068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.8D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7190892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86</TotalTime>
  <Words>32</Words>
  <Application>Microsoft Office PowerPoint</Application>
  <PresentationFormat>宽屏</PresentationFormat>
  <Paragraphs>24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7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强 李</dc:creator>
  <cp:lastModifiedBy>强 李</cp:lastModifiedBy>
  <cp:revision>13</cp:revision>
  <dcterms:created xsi:type="dcterms:W3CDTF">2023-10-27T00:31:13Z</dcterms:created>
  <dcterms:modified xsi:type="dcterms:W3CDTF">2023-11-21T12:05:22Z</dcterms:modified>
</cp:coreProperties>
</file>